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11"/>
  </p:notesMasterIdLst>
  <p:sldIdLst>
    <p:sldId id="288" r:id="rId3"/>
    <p:sldId id="275" r:id="rId4"/>
    <p:sldId id="274" r:id="rId5"/>
    <p:sldId id="290" r:id="rId6"/>
    <p:sldId id="291" r:id="rId7"/>
    <p:sldId id="293" r:id="rId8"/>
    <p:sldId id="289" r:id="rId9"/>
    <p:sldId id="295" r:id="rId10"/>
  </p:sldIdLst>
  <p:sldSz cx="6858000" cy="9144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83" autoAdjust="0"/>
    <p:restoredTop sz="94470" autoAdjust="0"/>
  </p:normalViewPr>
  <p:slideViewPr>
    <p:cSldViewPr>
      <p:cViewPr varScale="1">
        <p:scale>
          <a:sx n="81" d="100"/>
          <a:sy n="81" d="100"/>
        </p:scale>
        <p:origin x="2136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5" Type="http://schemas.openxmlformats.org/officeDocument/2006/relationships/tableStyles" Target="tableStyles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-iizaka\Desktop\MycG&#27231;&#33021;&#35299;&#26512;\MycG&#22793;&#30064;&#20307;&#30456;&#35036;\TC\Time%20course-1\Summary_TC-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-iizaka\Desktop\MycG&#27231;&#33021;&#35299;&#26512;\MycG&#22793;&#30064;&#20307;&#30456;&#35036;\TC\Time%20course-1\Summary_TC-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ver3'!$B$22</c:f>
              <c:strCache>
                <c:ptCount val="1"/>
                <c:pt idx="0">
                  <c:v>M-IV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ver3'!$C$3:$G$3</c:f>
              <c:numCache>
                <c:formatCode>General</c:formatCode>
                <c:ptCount val="5"/>
                <c:pt idx="0">
                  <c:v>4</c:v>
                </c:pt>
                <c:pt idx="1">
                  <c:v>6</c:v>
                </c:pt>
                <c:pt idx="2">
                  <c:v>8</c:v>
                </c:pt>
                <c:pt idx="3">
                  <c:v>10</c:v>
                </c:pt>
                <c:pt idx="4">
                  <c:v>14</c:v>
                </c:pt>
              </c:numCache>
            </c:numRef>
          </c:xVal>
          <c:yVal>
            <c:numRef>
              <c:f>'ver3'!$C$22:$G$22</c:f>
              <c:numCache>
                <c:formatCode>0.0_ 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26F-4FAD-94B2-26A59A1CAB99}"/>
            </c:ext>
          </c:extLst>
        </c:ser>
        <c:ser>
          <c:idx val="1"/>
          <c:order val="1"/>
          <c:tx>
            <c:strRef>
              <c:f>'ver3'!$B$23</c:f>
              <c:strCache>
                <c:ptCount val="1"/>
                <c:pt idx="0">
                  <c:v>M-I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ver3'!$C$3:$G$3</c:f>
              <c:numCache>
                <c:formatCode>General</c:formatCode>
                <c:ptCount val="5"/>
                <c:pt idx="0">
                  <c:v>4</c:v>
                </c:pt>
                <c:pt idx="1">
                  <c:v>6</c:v>
                </c:pt>
                <c:pt idx="2">
                  <c:v>8</c:v>
                </c:pt>
                <c:pt idx="3">
                  <c:v>10</c:v>
                </c:pt>
                <c:pt idx="4">
                  <c:v>14</c:v>
                </c:pt>
              </c:numCache>
            </c:numRef>
          </c:xVal>
          <c:yVal>
            <c:numRef>
              <c:f>'ver3'!$C$23:$G$23</c:f>
              <c:numCache>
                <c:formatCode>0.0_ </c:formatCode>
                <c:ptCount val="5"/>
                <c:pt idx="0">
                  <c:v>2.0054141344515188</c:v>
                </c:pt>
                <c:pt idx="1">
                  <c:v>3.8942339070153311</c:v>
                </c:pt>
                <c:pt idx="2">
                  <c:v>3.6961022502044396</c:v>
                </c:pt>
                <c:pt idx="3">
                  <c:v>3.9030536724979861</c:v>
                </c:pt>
                <c:pt idx="4">
                  <c:v>3.026200635210615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26F-4FAD-94B2-26A59A1CAB99}"/>
            </c:ext>
          </c:extLst>
        </c:ser>
        <c:ser>
          <c:idx val="2"/>
          <c:order val="2"/>
          <c:tx>
            <c:strRef>
              <c:f>'ver3'!$B$24</c:f>
              <c:strCache>
                <c:ptCount val="1"/>
                <c:pt idx="0">
                  <c:v>M-V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ver3'!$C$3:$G$3</c:f>
              <c:numCache>
                <c:formatCode>General</c:formatCode>
                <c:ptCount val="5"/>
                <c:pt idx="0">
                  <c:v>4</c:v>
                </c:pt>
                <c:pt idx="1">
                  <c:v>6</c:v>
                </c:pt>
                <c:pt idx="2">
                  <c:v>8</c:v>
                </c:pt>
                <c:pt idx="3">
                  <c:v>10</c:v>
                </c:pt>
                <c:pt idx="4">
                  <c:v>14</c:v>
                </c:pt>
              </c:numCache>
            </c:numRef>
          </c:xVal>
          <c:yVal>
            <c:numRef>
              <c:f>'ver3'!$C$24:$G$24</c:f>
              <c:numCache>
                <c:formatCode>0.0_ </c:formatCode>
                <c:ptCount val="5"/>
                <c:pt idx="0">
                  <c:v>0</c:v>
                </c:pt>
                <c:pt idx="1">
                  <c:v>0.16110952808263906</c:v>
                </c:pt>
                <c:pt idx="2">
                  <c:v>0.17098154562014367</c:v>
                </c:pt>
                <c:pt idx="3">
                  <c:v>0</c:v>
                </c:pt>
                <c:pt idx="4">
                  <c:v>0.3606595724512309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626F-4FAD-94B2-26A59A1CAB99}"/>
            </c:ext>
          </c:extLst>
        </c:ser>
        <c:ser>
          <c:idx val="3"/>
          <c:order val="3"/>
          <c:tx>
            <c:strRef>
              <c:f>'ver3'!$B$25</c:f>
              <c:strCache>
                <c:ptCount val="1"/>
                <c:pt idx="0">
                  <c:v>M-II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ver3'!$C$3:$G$3</c:f>
              <c:numCache>
                <c:formatCode>General</c:formatCode>
                <c:ptCount val="5"/>
                <c:pt idx="0">
                  <c:v>4</c:v>
                </c:pt>
                <c:pt idx="1">
                  <c:v>6</c:v>
                </c:pt>
                <c:pt idx="2">
                  <c:v>8</c:v>
                </c:pt>
                <c:pt idx="3">
                  <c:v>10</c:v>
                </c:pt>
                <c:pt idx="4">
                  <c:v>14</c:v>
                </c:pt>
              </c:numCache>
            </c:numRef>
          </c:xVal>
          <c:yVal>
            <c:numRef>
              <c:f>'ver3'!$C$25:$G$25</c:f>
              <c:numCache>
                <c:formatCode>0.0_ </c:formatCode>
                <c:ptCount val="5"/>
                <c:pt idx="0">
                  <c:v>4.6156558806411789</c:v>
                </c:pt>
                <c:pt idx="1">
                  <c:v>13.304217503014149</c:v>
                </c:pt>
                <c:pt idx="2">
                  <c:v>10.858255850434935</c:v>
                </c:pt>
                <c:pt idx="3">
                  <c:v>13.438686514053922</c:v>
                </c:pt>
                <c:pt idx="4">
                  <c:v>11.04004565425365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626F-4FAD-94B2-26A59A1CAB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4991728"/>
        <c:axId val="364992904"/>
      </c:scatterChart>
      <c:valAx>
        <c:axId val="364991728"/>
        <c:scaling>
          <c:orientation val="minMax"/>
          <c:max val="14"/>
          <c:min val="4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64992904"/>
        <c:crosses val="autoZero"/>
        <c:crossBetween val="midCat"/>
      </c:valAx>
      <c:valAx>
        <c:axId val="364992904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_ 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649917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ver3'!$B$29</c:f>
              <c:strCache>
                <c:ptCount val="1"/>
                <c:pt idx="0">
                  <c:v>M-IV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ver3'!$C$3:$G$3</c:f>
              <c:numCache>
                <c:formatCode>General</c:formatCode>
                <c:ptCount val="5"/>
                <c:pt idx="0">
                  <c:v>4</c:v>
                </c:pt>
                <c:pt idx="1">
                  <c:v>6</c:v>
                </c:pt>
                <c:pt idx="2">
                  <c:v>8</c:v>
                </c:pt>
                <c:pt idx="3">
                  <c:v>10</c:v>
                </c:pt>
                <c:pt idx="4">
                  <c:v>14</c:v>
                </c:pt>
              </c:numCache>
            </c:numRef>
          </c:xVal>
          <c:yVal>
            <c:numRef>
              <c:f>'ver3'!$C$29:$G$29</c:f>
              <c:numCache>
                <c:formatCode>0.0_ </c:formatCode>
                <c:ptCount val="5"/>
                <c:pt idx="0">
                  <c:v>6.6363960367798676</c:v>
                </c:pt>
                <c:pt idx="1">
                  <c:v>8.3813729910117463</c:v>
                </c:pt>
                <c:pt idx="2">
                  <c:v>8.5614750932057007</c:v>
                </c:pt>
                <c:pt idx="3">
                  <c:v>6.8916310313424072</c:v>
                </c:pt>
                <c:pt idx="4">
                  <c:v>5.267102674990566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E55-48D7-B25D-D83A9588CECF}"/>
            </c:ext>
          </c:extLst>
        </c:ser>
        <c:ser>
          <c:idx val="1"/>
          <c:order val="1"/>
          <c:tx>
            <c:strRef>
              <c:f>'ver3'!$B$30</c:f>
              <c:strCache>
                <c:ptCount val="1"/>
                <c:pt idx="0">
                  <c:v>M-I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ver3'!$C$3:$G$3</c:f>
              <c:numCache>
                <c:formatCode>General</c:formatCode>
                <c:ptCount val="5"/>
                <c:pt idx="0">
                  <c:v>4</c:v>
                </c:pt>
                <c:pt idx="1">
                  <c:v>6</c:v>
                </c:pt>
                <c:pt idx="2">
                  <c:v>8</c:v>
                </c:pt>
                <c:pt idx="3">
                  <c:v>10</c:v>
                </c:pt>
                <c:pt idx="4">
                  <c:v>14</c:v>
                </c:pt>
              </c:numCache>
            </c:numRef>
          </c:xVal>
          <c:yVal>
            <c:numRef>
              <c:f>'ver3'!$C$30:$G$30</c:f>
              <c:numCache>
                <c:formatCode>0.0_ </c:formatCode>
                <c:ptCount val="5"/>
                <c:pt idx="0">
                  <c:v>0.51612577861794895</c:v>
                </c:pt>
                <c:pt idx="1">
                  <c:v>0.86401181638898827</c:v>
                </c:pt>
                <c:pt idx="2">
                  <c:v>0.96575116414732909</c:v>
                </c:pt>
                <c:pt idx="3">
                  <c:v>0.67136642412568659</c:v>
                </c:pt>
                <c:pt idx="4">
                  <c:v>0.7786367419771473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E55-48D7-B25D-D83A9588CECF}"/>
            </c:ext>
          </c:extLst>
        </c:ser>
        <c:ser>
          <c:idx val="2"/>
          <c:order val="2"/>
          <c:tx>
            <c:strRef>
              <c:f>'ver3'!$B$31</c:f>
              <c:strCache>
                <c:ptCount val="1"/>
                <c:pt idx="0">
                  <c:v>M-V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ver3'!$C$3:$G$3</c:f>
              <c:numCache>
                <c:formatCode>General</c:formatCode>
                <c:ptCount val="5"/>
                <c:pt idx="0">
                  <c:v>4</c:v>
                </c:pt>
                <c:pt idx="1">
                  <c:v>6</c:v>
                </c:pt>
                <c:pt idx="2">
                  <c:v>8</c:v>
                </c:pt>
                <c:pt idx="3">
                  <c:v>10</c:v>
                </c:pt>
                <c:pt idx="4">
                  <c:v>14</c:v>
                </c:pt>
              </c:numCache>
            </c:numRef>
          </c:xVal>
          <c:yVal>
            <c:numRef>
              <c:f>'ver3'!$C$31:$G$31</c:f>
              <c:numCache>
                <c:formatCode>0.0_ </c:formatCode>
                <c:ptCount val="5"/>
                <c:pt idx="0">
                  <c:v>7.6205851706709815</c:v>
                </c:pt>
                <c:pt idx="1">
                  <c:v>11.161539367149254</c:v>
                </c:pt>
                <c:pt idx="2">
                  <c:v>15.70296752116224</c:v>
                </c:pt>
                <c:pt idx="3">
                  <c:v>16.33306937705045</c:v>
                </c:pt>
                <c:pt idx="4">
                  <c:v>13.63863076122548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E55-48D7-B25D-D83A9588CECF}"/>
            </c:ext>
          </c:extLst>
        </c:ser>
        <c:ser>
          <c:idx val="3"/>
          <c:order val="3"/>
          <c:tx>
            <c:strRef>
              <c:f>'ver3'!$B$32</c:f>
              <c:strCache>
                <c:ptCount val="1"/>
                <c:pt idx="0">
                  <c:v>M-II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ver3'!$C$3:$G$3</c:f>
              <c:numCache>
                <c:formatCode>General</c:formatCode>
                <c:ptCount val="5"/>
                <c:pt idx="0">
                  <c:v>4</c:v>
                </c:pt>
                <c:pt idx="1">
                  <c:v>6</c:v>
                </c:pt>
                <c:pt idx="2">
                  <c:v>8</c:v>
                </c:pt>
                <c:pt idx="3">
                  <c:v>10</c:v>
                </c:pt>
                <c:pt idx="4">
                  <c:v>14</c:v>
                </c:pt>
              </c:numCache>
            </c:numRef>
          </c:xVal>
          <c:yVal>
            <c:numRef>
              <c:f>'ver3'!$C$32:$G$32</c:f>
              <c:numCache>
                <c:formatCode>0.0_ </c:formatCode>
                <c:ptCount val="5"/>
                <c:pt idx="0">
                  <c:v>0.39415786281358728</c:v>
                </c:pt>
                <c:pt idx="1">
                  <c:v>2.1228222500985208</c:v>
                </c:pt>
                <c:pt idx="2">
                  <c:v>3.6564165556439105</c:v>
                </c:pt>
                <c:pt idx="3">
                  <c:v>4.3522007225651613</c:v>
                </c:pt>
                <c:pt idx="4">
                  <c:v>2.888096057527048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DE55-48D7-B25D-D83A9588CE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4996432"/>
        <c:axId val="364993296"/>
      </c:scatterChart>
      <c:valAx>
        <c:axId val="364996432"/>
        <c:scaling>
          <c:orientation val="minMax"/>
          <c:max val="14"/>
          <c:min val="4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64993296"/>
        <c:crosses val="autoZero"/>
        <c:crossBetween val="midCat"/>
      </c:valAx>
      <c:valAx>
        <c:axId val="364993296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_ 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6499643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7207688698803667"/>
          <c:y val="0.86230552481343414"/>
          <c:w val="0.72510333385125192"/>
          <c:h val="0.1015780780104699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21582" cy="493633"/>
          </a:xfrm>
          <a:prstGeom prst="rect">
            <a:avLst/>
          </a:prstGeom>
        </p:spPr>
        <p:txBody>
          <a:bodyPr vert="horz" lIns="91431" tIns="45716" rIns="91431" bIns="4571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8971" y="1"/>
            <a:ext cx="2921582" cy="493633"/>
          </a:xfrm>
          <a:prstGeom prst="rect">
            <a:avLst/>
          </a:prstGeom>
        </p:spPr>
        <p:txBody>
          <a:bodyPr vert="horz" lIns="91431" tIns="45716" rIns="91431" bIns="45716" rtlCol="0"/>
          <a:lstStyle>
            <a:lvl1pPr algn="r">
              <a:defRPr sz="1200"/>
            </a:lvl1pPr>
          </a:lstStyle>
          <a:p>
            <a:fld id="{3D0E9F3D-A664-4F58-AA31-1E853076A848}" type="datetimeFigureOut">
              <a:rPr kumimoji="1" lang="ja-JP" altLang="en-US" smtClean="0"/>
              <a:pPr/>
              <a:t>2021/9/24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82788" y="739775"/>
            <a:ext cx="2776537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6" rIns="91431" bIns="45716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4212" y="4689515"/>
            <a:ext cx="5393690" cy="4442698"/>
          </a:xfrm>
          <a:prstGeom prst="rect">
            <a:avLst/>
          </a:prstGeom>
        </p:spPr>
        <p:txBody>
          <a:bodyPr vert="horz" lIns="91431" tIns="45716" rIns="91431" bIns="45716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921582" cy="493633"/>
          </a:xfrm>
          <a:prstGeom prst="rect">
            <a:avLst/>
          </a:prstGeom>
        </p:spPr>
        <p:txBody>
          <a:bodyPr vert="horz" lIns="91431" tIns="45716" rIns="91431" bIns="4571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8971" y="9377316"/>
            <a:ext cx="2921582" cy="493633"/>
          </a:xfrm>
          <a:prstGeom prst="rect">
            <a:avLst/>
          </a:prstGeom>
        </p:spPr>
        <p:txBody>
          <a:bodyPr vert="horz" lIns="91431" tIns="45716" rIns="91431" bIns="45716" rtlCol="0" anchor="b"/>
          <a:lstStyle>
            <a:lvl1pPr algn="r">
              <a:defRPr sz="1200"/>
            </a:lvl1pPr>
          </a:lstStyle>
          <a:p>
            <a:fld id="{D53C69EC-24F7-43D9-A9EE-B1870BAFD94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7652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EE8FF91-A195-4D42-AB3D-5D72D286E3FD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6994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BAEE9E3-3B7D-4CF4-86E7-6B9E6ABFD28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67311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623E4B-52A5-4101-B31F-DAE23B6D521E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556351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15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2"/>
          </a:xfrm>
        </p:spPr>
        <p:txBody>
          <a:bodyPr/>
          <a:lstStyle>
            <a:lvl1pPr marL="0" indent="0" algn="ctr">
              <a:buNone/>
              <a:defRPr sz="1662"/>
            </a:lvl1pPr>
            <a:lvl2pPr marL="316531" indent="0" algn="ctr">
              <a:buNone/>
              <a:defRPr sz="1385"/>
            </a:lvl2pPr>
            <a:lvl3pPr marL="633062" indent="0" algn="ctr">
              <a:buNone/>
              <a:defRPr sz="1246"/>
            </a:lvl3pPr>
            <a:lvl4pPr marL="949593" indent="0" algn="ctr">
              <a:buNone/>
              <a:defRPr sz="1108"/>
            </a:lvl4pPr>
            <a:lvl5pPr marL="1266124" indent="0" algn="ctr">
              <a:buNone/>
              <a:defRPr sz="1108"/>
            </a:lvl5pPr>
            <a:lvl6pPr marL="1582655" indent="0" algn="ctr">
              <a:buNone/>
              <a:defRPr sz="1108"/>
            </a:lvl6pPr>
            <a:lvl7pPr marL="1899186" indent="0" algn="ctr">
              <a:buNone/>
              <a:defRPr sz="1108"/>
            </a:lvl7pPr>
            <a:lvl8pPr marL="2215717" indent="0" algn="ctr">
              <a:buNone/>
              <a:defRPr sz="1108"/>
            </a:lvl8pPr>
            <a:lvl9pPr marL="2532248" indent="0" algn="ctr">
              <a:buNone/>
              <a:defRPr sz="1108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289195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0457853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279653"/>
            <a:ext cx="5915025" cy="3803649"/>
          </a:xfrm>
        </p:spPr>
        <p:txBody>
          <a:bodyPr anchor="b"/>
          <a:lstStyle>
            <a:lvl1pPr>
              <a:defRPr sz="415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119288"/>
            <a:ext cx="5915025" cy="2000250"/>
          </a:xfrm>
        </p:spPr>
        <p:txBody>
          <a:bodyPr/>
          <a:lstStyle>
            <a:lvl1pPr marL="0" indent="0">
              <a:buNone/>
              <a:defRPr sz="1662">
                <a:solidFill>
                  <a:schemeClr val="tx1"/>
                </a:solidFill>
              </a:defRPr>
            </a:lvl1pPr>
            <a:lvl2pPr marL="316531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2pPr>
            <a:lvl3pPr marL="633062" indent="0">
              <a:buNone/>
              <a:defRPr sz="1246">
                <a:solidFill>
                  <a:schemeClr val="tx1">
                    <a:tint val="75000"/>
                  </a:schemeClr>
                </a:solidFill>
              </a:defRPr>
            </a:lvl3pPr>
            <a:lvl4pPr marL="949593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4pPr>
            <a:lvl5pPr marL="1266124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5pPr>
            <a:lvl6pPr marL="1582655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6pPr>
            <a:lvl7pPr marL="1899186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7pPr>
            <a:lvl8pPr marL="221571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8pPr>
            <a:lvl9pPr marL="253224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0512663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4912876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241554"/>
            <a:ext cx="2901255" cy="1098549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31" indent="0">
              <a:buNone/>
              <a:defRPr sz="1385" b="1"/>
            </a:lvl2pPr>
            <a:lvl3pPr marL="633062" indent="0">
              <a:buNone/>
              <a:defRPr sz="1246" b="1"/>
            </a:lvl3pPr>
            <a:lvl4pPr marL="949593" indent="0">
              <a:buNone/>
              <a:defRPr sz="1108" b="1"/>
            </a:lvl4pPr>
            <a:lvl5pPr marL="1266124" indent="0">
              <a:buNone/>
              <a:defRPr sz="1108" b="1"/>
            </a:lvl5pPr>
            <a:lvl6pPr marL="1582655" indent="0">
              <a:buNone/>
              <a:defRPr sz="1108" b="1"/>
            </a:lvl6pPr>
            <a:lvl7pPr marL="1899186" indent="0">
              <a:buNone/>
              <a:defRPr sz="1108" b="1"/>
            </a:lvl7pPr>
            <a:lvl8pPr marL="2215717" indent="0">
              <a:buNone/>
              <a:defRPr sz="1108" b="1"/>
            </a:lvl8pPr>
            <a:lvl9pPr marL="2532248" indent="0">
              <a:buNone/>
              <a:defRPr sz="1108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340103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241554"/>
            <a:ext cx="2915543" cy="1098549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31" indent="0">
              <a:buNone/>
              <a:defRPr sz="1385" b="1"/>
            </a:lvl2pPr>
            <a:lvl3pPr marL="633062" indent="0">
              <a:buNone/>
              <a:defRPr sz="1246" b="1"/>
            </a:lvl3pPr>
            <a:lvl4pPr marL="949593" indent="0">
              <a:buNone/>
              <a:defRPr sz="1108" b="1"/>
            </a:lvl4pPr>
            <a:lvl5pPr marL="1266124" indent="0">
              <a:buNone/>
              <a:defRPr sz="1108" b="1"/>
            </a:lvl5pPr>
            <a:lvl6pPr marL="1582655" indent="0">
              <a:buNone/>
              <a:defRPr sz="1108" b="1"/>
            </a:lvl6pPr>
            <a:lvl7pPr marL="1899186" indent="0">
              <a:buNone/>
              <a:defRPr sz="1108" b="1"/>
            </a:lvl7pPr>
            <a:lvl8pPr marL="2215717" indent="0">
              <a:buNone/>
              <a:defRPr sz="1108" b="1"/>
            </a:lvl8pPr>
            <a:lvl9pPr marL="2532248" indent="0">
              <a:buNone/>
              <a:defRPr sz="1108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340103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633487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2263817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8248422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316571"/>
            <a:ext cx="3471863" cy="6498167"/>
          </a:xfrm>
        </p:spPr>
        <p:txBody>
          <a:bodyPr/>
          <a:lstStyle>
            <a:lvl1pPr>
              <a:defRPr sz="2215"/>
            </a:lvl1pPr>
            <a:lvl2pPr>
              <a:defRPr sz="1939"/>
            </a:lvl2pPr>
            <a:lvl3pPr>
              <a:defRPr sz="1662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108"/>
            </a:lvl1pPr>
            <a:lvl2pPr marL="316531" indent="0">
              <a:buNone/>
              <a:defRPr sz="969"/>
            </a:lvl2pPr>
            <a:lvl3pPr marL="633062" indent="0">
              <a:buNone/>
              <a:defRPr sz="831"/>
            </a:lvl3pPr>
            <a:lvl4pPr marL="949593" indent="0">
              <a:buNone/>
              <a:defRPr sz="692"/>
            </a:lvl4pPr>
            <a:lvl5pPr marL="1266124" indent="0">
              <a:buNone/>
              <a:defRPr sz="692"/>
            </a:lvl5pPr>
            <a:lvl6pPr marL="1582655" indent="0">
              <a:buNone/>
              <a:defRPr sz="692"/>
            </a:lvl6pPr>
            <a:lvl7pPr marL="1899186" indent="0">
              <a:buNone/>
              <a:defRPr sz="692"/>
            </a:lvl7pPr>
            <a:lvl8pPr marL="2215717" indent="0">
              <a:buNone/>
              <a:defRPr sz="692"/>
            </a:lvl8pPr>
            <a:lvl9pPr marL="2532248" indent="0">
              <a:buNone/>
              <a:defRPr sz="692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96389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66C463B-AD62-44DF-B85E-4CC62572C837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536949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316571"/>
            <a:ext cx="3471863" cy="6498167"/>
          </a:xfrm>
        </p:spPr>
        <p:txBody>
          <a:bodyPr anchor="t"/>
          <a:lstStyle>
            <a:lvl1pPr marL="0" indent="0">
              <a:buNone/>
              <a:defRPr sz="2215"/>
            </a:lvl1pPr>
            <a:lvl2pPr marL="316531" indent="0">
              <a:buNone/>
              <a:defRPr sz="1939"/>
            </a:lvl2pPr>
            <a:lvl3pPr marL="633062" indent="0">
              <a:buNone/>
              <a:defRPr sz="1662"/>
            </a:lvl3pPr>
            <a:lvl4pPr marL="949593" indent="0">
              <a:buNone/>
              <a:defRPr sz="1385"/>
            </a:lvl4pPr>
            <a:lvl5pPr marL="1266124" indent="0">
              <a:buNone/>
              <a:defRPr sz="1385"/>
            </a:lvl5pPr>
            <a:lvl6pPr marL="1582655" indent="0">
              <a:buNone/>
              <a:defRPr sz="1385"/>
            </a:lvl6pPr>
            <a:lvl7pPr marL="1899186" indent="0">
              <a:buNone/>
              <a:defRPr sz="1385"/>
            </a:lvl7pPr>
            <a:lvl8pPr marL="2215717" indent="0">
              <a:buNone/>
              <a:defRPr sz="1385"/>
            </a:lvl8pPr>
            <a:lvl9pPr marL="2532248" indent="0">
              <a:buNone/>
              <a:defRPr sz="1385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108"/>
            </a:lvl1pPr>
            <a:lvl2pPr marL="316531" indent="0">
              <a:buNone/>
              <a:defRPr sz="969"/>
            </a:lvl2pPr>
            <a:lvl3pPr marL="633062" indent="0">
              <a:buNone/>
              <a:defRPr sz="831"/>
            </a:lvl3pPr>
            <a:lvl4pPr marL="949593" indent="0">
              <a:buNone/>
              <a:defRPr sz="692"/>
            </a:lvl4pPr>
            <a:lvl5pPr marL="1266124" indent="0">
              <a:buNone/>
              <a:defRPr sz="692"/>
            </a:lvl5pPr>
            <a:lvl6pPr marL="1582655" indent="0">
              <a:buNone/>
              <a:defRPr sz="692"/>
            </a:lvl6pPr>
            <a:lvl7pPr marL="1899186" indent="0">
              <a:buNone/>
              <a:defRPr sz="692"/>
            </a:lvl7pPr>
            <a:lvl8pPr marL="2215717" indent="0">
              <a:buNone/>
              <a:defRPr sz="692"/>
            </a:lvl8pPr>
            <a:lvl9pPr marL="2532248" indent="0">
              <a:buNone/>
              <a:defRPr sz="692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6023536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5025865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6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6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0634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23201F1-DF53-41F3-A649-484265FABB5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51858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2428C79-4B7C-418A-AC9E-9063CE3E9F7D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319263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51793D8-0C6D-46E1-9816-4CC24F200B22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4933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4D58BF8-3EDC-4E83-A65D-A4987204C4E2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82500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56338D-A5CC-42A7-BB73-B269A0F499B2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16881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DF78E97-8E64-4D7E-8F79-39440D70127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19956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8FA01B2-7351-4E51-A871-628A05EE3015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16534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11612903-FAD9-4F41-B407-BA4C02A270BA}" type="slidenum">
              <a:rPr lang="en-US" altLang="ja-JP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4874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84D4F9-710A-47CF-9C10-9F0EA0EE1B0D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9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8475138"/>
            <a:ext cx="2314575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A795E-13D5-455A-8B8B-EC00B85B0DF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842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33062" rtl="0" eaLnBrk="1" latinLnBrk="0" hangingPunct="1">
        <a:lnSpc>
          <a:spcPct val="90000"/>
        </a:lnSpc>
        <a:spcBef>
          <a:spcPct val="0"/>
        </a:spcBef>
        <a:buNone/>
        <a:defRPr kumimoji="1" sz="30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8265" indent="-158265" algn="l" defTabSz="633062" rtl="0" eaLnBrk="1" latinLnBrk="0" hangingPunct="1">
        <a:lnSpc>
          <a:spcPct val="90000"/>
        </a:lnSpc>
        <a:spcBef>
          <a:spcPts val="692"/>
        </a:spcBef>
        <a:buFont typeface="Arial" panose="020B0604020202020204" pitchFamily="34" charset="0"/>
        <a:buChar char="•"/>
        <a:defRPr kumimoji="1" sz="1939" kern="1200">
          <a:solidFill>
            <a:schemeClr val="tx1"/>
          </a:solidFill>
          <a:latin typeface="+mn-lt"/>
          <a:ea typeface="+mn-ea"/>
          <a:cs typeface="+mn-cs"/>
        </a:defRPr>
      </a:lvl1pPr>
      <a:lvl2pPr marL="474796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791327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385" kern="1200">
          <a:solidFill>
            <a:schemeClr val="tx1"/>
          </a:solidFill>
          <a:latin typeface="+mn-lt"/>
          <a:ea typeface="+mn-ea"/>
          <a:cs typeface="+mn-cs"/>
        </a:defRPr>
      </a:lvl3pPr>
      <a:lvl4pPr marL="1107858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424389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740920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2057451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373982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690513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16531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633062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3pPr>
      <a:lvl4pPr marL="949593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266124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582655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1899186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215717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532248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16632" y="284033"/>
            <a:ext cx="6624736" cy="6694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ournal of Industrial Microbiology and Biotechnology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ectronic Supplementary Material for:</a:t>
            </a:r>
          </a:p>
          <a:p>
            <a:endParaRPr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ja-JP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endParaRPr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gineering Sequence and Selectivity of Late-Stage C-H Oxidation in the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G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terative Cytochrome P450</a:t>
            </a:r>
          </a:p>
          <a:p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ohe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izak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·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yuse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rai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·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kari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akahashi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·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ikin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to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· Miho Sakai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·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tsushi Fukumoto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·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vi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erman</a:t>
            </a:r>
            <a:r>
              <a:rPr lang="en-US" altLang="ja-JP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ja-JP" alt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·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ojiro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zai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 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Faculty of Pharmaceutical Sciences, Toho University, 2-2-1 Miyama, Funabashi, Chiba, </a:t>
            </a:r>
            <a:r>
              <a:rPr lang="en-US" altLang="ja-JP" sz="1200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Japan</a:t>
            </a:r>
          </a:p>
          <a:p>
            <a:pPr>
              <a:lnSpc>
                <a:spcPct val="200000"/>
              </a:lnSpc>
            </a:pP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fe Sciences Institute, Department of Medicinal Chemistry, Chemistry, and Microbiology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amp;    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mmunology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University of Michigan, Ann Arbor, Michigan, USA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endParaRPr lang="ja-JP" altLang="ja-JP" sz="1400" kern="100" dirty="0" smtClean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rrespondence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ohe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izaka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Faculty of Pharmaceutical Sciences, Toho University, 2-2-1 Miyama, Funabashi, Chiba 274-8510, Japan. Tel.: +81 47 472 2068; Fax.: +81 47 472 2086; 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mail: </a:t>
            </a:r>
            <a:r>
              <a:rPr lang="en-US" altLang="ja-JP" sz="12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ohei.iizaka@phar.toho-u.ac.jp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38661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1543482"/>
              </p:ext>
            </p:extLst>
          </p:nvPr>
        </p:nvGraphicFramePr>
        <p:xfrm>
          <a:off x="63674" y="467544"/>
          <a:ext cx="6696744" cy="4378925"/>
        </p:xfrm>
        <a:graphic>
          <a:graphicData uri="http://schemas.openxmlformats.org/drawingml/2006/table">
            <a:tbl>
              <a:tblPr/>
              <a:tblGrid>
                <a:gridCol w="196974"/>
                <a:gridCol w="792088"/>
                <a:gridCol w="4195514"/>
                <a:gridCol w="1512168"/>
              </a:tblGrid>
              <a:tr h="262001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able S1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/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trains and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lasmids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used in this study.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1987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train or plasmid 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Description or genotype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ource or reference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75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. coli 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JM109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loning host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akara Bio, Japan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osseta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2 (DE3)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otein expression host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ovagen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, Merck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KGaA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, Germany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TCC 47055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jugation donor (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. coli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S17-1)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merican Type Culture Collection (ATCC)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. griseorubida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11725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Wild type, mycinamicin producer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atoi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et al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.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98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PMA0025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deletion derivative of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. griseorubida 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11725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zai et al. 2012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PMA0047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0 including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induced into TPMA0025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zai et al. 2012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PMA0073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2 including gene encoding MycG mutant R111Q/V358L induced in TPMA0025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s study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PMA0074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3 including gene encoding MycG mutant W44R induced in TPMA0025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s study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PMA0075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4 including gene encoding MycG mutant V135G/E355K induced in TPMA0025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s study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PMA0076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5 including gene encoding MycG mutant V135G induced in TPMA0025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s study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PMA0077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6 including gene encod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E355K induced in TPMA0025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s study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lasmids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Driv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sv-S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A cloning vector, </a:t>
                      </a:r>
                      <a:r>
                        <a:rPr lang="sv-SE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bla</a:t>
                      </a:r>
                      <a:r>
                        <a:rPr lang="sv-S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, </a:t>
                      </a:r>
                      <a:r>
                        <a:rPr lang="sv-SE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ph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Qiagen, Germany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CYPcamAB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450 protein expression plasmid: </a:t>
                      </a:r>
                      <a:r>
                        <a:rPr lang="it-IT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bla, camA, camB</a:t>
                      </a:r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gematu et al. 2006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CGcamAB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otein-coding region of </a:t>
                      </a:r>
                      <a:r>
                        <a:rPr lang="en-US" sz="9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inserted into </a:t>
                      </a:r>
                      <a:r>
                        <a:rPr lang="en-US" sz="9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CYPcamA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s study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SET152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ac(3)IV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,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oriT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,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attP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,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int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Bierman et al. 1992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0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2-kb ApaLI-NruI fragment on the chromosome of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. griseorubida 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11725 including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inserted into pSET152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zai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et al. 2012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2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e gene encoding MycG mutant R111Q/V358L replaced with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on pMG520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s study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3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e gene encoding MycG mutant W44R replaced with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on pMG520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s study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4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e gene encoding MycG mutant V135G/E355K replaced with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on pMG520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s study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5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e gene encoding MycG mutant V135G replaced with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on pMG520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s study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750"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7237" marR="7237" marT="72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G526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e gene encoding MycG mutant E355K replaced with mycG on pMG520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s study</a:t>
                      </a:r>
                    </a:p>
                  </a:txBody>
                  <a:tcPr marL="7237" marR="7237" marT="72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235763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5134714"/>
              </p:ext>
            </p:extLst>
          </p:nvPr>
        </p:nvGraphicFramePr>
        <p:xfrm>
          <a:off x="75104" y="611560"/>
          <a:ext cx="6731122" cy="5040005"/>
        </p:xfrm>
        <a:graphic>
          <a:graphicData uri="http://schemas.openxmlformats.org/drawingml/2006/table">
            <a:tbl>
              <a:tblPr/>
              <a:tblGrid>
                <a:gridCol w="1213890"/>
                <a:gridCol w="2880320"/>
                <a:gridCol w="2636912"/>
              </a:tblGrid>
              <a:tr h="373505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able S2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/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CR primers used in this study.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imer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urpose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equence (5'-3')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_NdeI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-F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mprification of protein-coding region of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TCATATGACTTCAGCTGAACCTAGGGCGT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_SpeI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-R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mprification of protein-coding region of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TACTAGTTCACCACACGACCGGCAGCTCGAGT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_RM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-F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ntroduction of random mutation into </a:t>
                      </a:r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 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ene region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ATATGACTTCAGCTGAACCTAGGGCGT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_RM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-R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ntroduction of random mutation into </a:t>
                      </a:r>
                      <a:r>
                        <a:rPr lang="en-US" sz="9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ene region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CTAGTTCACCACACGACCGGCAGCTCGAGT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2_g332a-F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R111Q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CGCTGCAGCCCCGTGCCCGCGAGATC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2_g332a-R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R111Q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CGGGGCTGCAGCGACTCCGCCCGACG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2_c464t-F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S155F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TCCCGTTCGCCGACCACGACCGCTTC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2_c464t-R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S155F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TCGGCGAACGGGACACCGAGCAGTTC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2_g1072t-F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V358L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CTCCAGTTGGCACTGGAGGTCCTGCT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2_g1072t-R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V358L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GTGCCAACTGGAGTTCCACCCGGGCC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6_t130a-F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W44R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GAGGCGAGGCTCGTCACCCGGTACGA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6_t130a-R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W44R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CGAGCCTCGCCTCCTCCCCGTAGGGC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8_t404g-F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V135G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ACCTGGGGGCCATGTTCGCCCGGCAG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8_t404g-R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V135G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ATGGCCCCCAGGTCGGCTGGCTGCCC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8_g1063a-F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 E355K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CGGGTGAAACTCCAGGTGGCACTGGA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-RM98_g1063a-R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ion of plasmid expressing MycG mutant E355K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GGAGTTTCACCCGGGCCAGAGGAGCG</a:t>
                      </a:r>
                    </a:p>
                  </a:txBody>
                  <a:tcPr marL="7862" marR="7862" marT="78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751977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9075902"/>
              </p:ext>
            </p:extLst>
          </p:nvPr>
        </p:nvGraphicFramePr>
        <p:xfrm>
          <a:off x="208906" y="179512"/>
          <a:ext cx="6624736" cy="8856970"/>
        </p:xfrm>
        <a:graphic>
          <a:graphicData uri="http://schemas.openxmlformats.org/drawingml/2006/table">
            <a:tbl>
              <a:tblPr/>
              <a:tblGrid>
                <a:gridCol w="1007407"/>
                <a:gridCol w="1007407"/>
                <a:gridCol w="1007407"/>
                <a:gridCol w="1007407"/>
                <a:gridCol w="1007407"/>
                <a:gridCol w="1007407"/>
                <a:gridCol w="580294"/>
              </a:tblGrid>
              <a:tr h="557248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able S3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/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e relative content of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inamicins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in the reaction mixture of M-IV </a:t>
                      </a:r>
                      <a:endParaRPr lang="en-US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d 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. coli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expressing wild-type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and its mutants. </a:t>
                      </a:r>
                    </a:p>
                  </a:txBody>
                  <a:tcPr marL="5277" marR="5277" marT="5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96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mutant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-IV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-I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-V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-II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%)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CYPcamA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wild-type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0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7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1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7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0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7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M9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4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2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3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111Q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0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3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2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155F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6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7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7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V358L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5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4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3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5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4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4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111Q/S155F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8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0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9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111Q/V358L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2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6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5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3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1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3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1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155F/V358L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1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5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8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M9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5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5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5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8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5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0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W44R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5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1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3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6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9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9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5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M9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9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8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7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9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8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9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V135G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9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1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0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355K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0.9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7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9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V135G/E355K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4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5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2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7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4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.3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4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3.6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7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49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.1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2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8</a:t>
                      </a: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7" marR="5277" marT="527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00856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3346468"/>
              </p:ext>
            </p:extLst>
          </p:nvPr>
        </p:nvGraphicFramePr>
        <p:xfrm>
          <a:off x="116632" y="251520"/>
          <a:ext cx="5460999" cy="3550920"/>
        </p:xfrm>
        <a:graphic>
          <a:graphicData uri="http://schemas.openxmlformats.org/drawingml/2006/table">
            <a:tbl>
              <a:tblPr/>
              <a:tblGrid>
                <a:gridCol w="1193400"/>
                <a:gridCol w="1193400"/>
                <a:gridCol w="1193400"/>
                <a:gridCol w="1193400"/>
                <a:gridCol w="687399"/>
              </a:tblGrid>
              <a:tr h="636270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able S4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/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e relative content of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inamicins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in the reaction mixture of M-V </a:t>
                      </a:r>
                      <a:endParaRPr lang="en-US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d 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. coli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expressing wild-type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and its mutants.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 mutan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-V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-II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wild-typ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7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7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7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111Q/V358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9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0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0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9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4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5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W44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3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6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5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4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4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5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V135G/E355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3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6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2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ver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7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2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327096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9080924"/>
              </p:ext>
            </p:extLst>
          </p:nvPr>
        </p:nvGraphicFramePr>
        <p:xfrm>
          <a:off x="404664" y="539552"/>
          <a:ext cx="6172200" cy="5916855"/>
        </p:xfrm>
        <a:graphic>
          <a:graphicData uri="http://schemas.openxmlformats.org/drawingml/2006/table">
            <a:tbl>
              <a:tblPr/>
              <a:tblGrid>
                <a:gridCol w="1543050"/>
                <a:gridCol w="1543050"/>
                <a:gridCol w="1543050"/>
                <a:gridCol w="1543050"/>
              </a:tblGrid>
              <a:tr h="666374">
                <a:tc gridSpan="4">
                  <a:txBody>
                    <a:bodyPr/>
                    <a:lstStyle/>
                    <a:p>
                      <a:pPr algn="l" fontAlgn="t"/>
                      <a:endParaRPr lang="en-US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  <a:p>
                      <a:pPr algn="l" fontAlgn="t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able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5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/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e expression level of wild-type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cG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and its mutants in whole-cell assays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333" marR="9333" marT="933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307988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otein 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centration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mg / mL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450 </a:t>
                      </a:r>
                      <a:b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</a:b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centration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6799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μ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ol / g of protein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μ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CYP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34 ± 0.44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0 ± 0.0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1 ± 0.03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Wild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98 ± 0.35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65 ± 0.18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26 ± 0.13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M92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86 ± 0.06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-0.01 ± 0.0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-0.01 ± 0.0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111Q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16 ± 0.40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4 ± 0.12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75 ± 0.38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155F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94 ± 0.30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6 ± 0.05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9 ± 0.05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V358L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95 ± 0.3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9 ± 0.04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7 ± 0.0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111Q/V358L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98 ± 0.18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2 ± 0.00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4 ± 0.00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155F/V358L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96 ± 0.50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4 ± 0.00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8 ± 0.0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M96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00 ± 0.30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2 ± 0.00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4 ± 0.0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W44R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02 ± 0.2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3 ± 0.0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5 ± 0.02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M98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42 ± 0.58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6 ± 0.02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8 ±0.00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V135G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92 ± 0.22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2 ± 0.02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25 ± 0.06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355K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94 ± 0.03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59 ± 0.09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16 ± 0.19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1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V135G/E355K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00 ± 0.2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5 ± 0.0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0 ± 0.03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3773">
                <a:tc gridSpan="4">
                  <a:txBody>
                    <a:bodyPr/>
                    <a:lstStyle/>
                    <a:p>
                      <a:pPr algn="l" rtl="0" fontAlgn="t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e protein concentration was measured using the Bradford protein assay. P450 (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ＭＳ Ｐゴシック" panose="020B0600070205080204" pitchFamily="50" charset="-128"/>
                        </a:rPr>
                        <a:t>m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ol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/ g of protein) content was calculated using the CO difference spectra and extinction coefficient of 91 mM</a:t>
                      </a:r>
                      <a:r>
                        <a:rPr lang="en-US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−</a:t>
                      </a:r>
                      <a:r>
                        <a:rPr lang="en-US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·cm</a:t>
                      </a:r>
                      <a:r>
                        <a:rPr lang="en-US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−</a:t>
                      </a:r>
                      <a:r>
                        <a:rPr lang="en-US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after adjustment of protein concentration to 1 mg/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L.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P450 (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ＭＳ Ｐゴシック" panose="020B0600070205080204" pitchFamily="50" charset="-128"/>
                        </a:rPr>
                        <a:t>m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) content in each sample was calculated from dilution rate. Errors are the standard deviations of the results from duplicate experiments.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</a:b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333" marR="9333" marT="933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829233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738749" y="665122"/>
            <a:ext cx="2160000" cy="2160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 flipH="1">
            <a:off x="2935982" y="935121"/>
            <a:ext cx="2160000" cy="16200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739757" y="467544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M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971580" y="46754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1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183947" y="46754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2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377862" y="46754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3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581009" y="46754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4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794138" y="46754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5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978700" y="46754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6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174006" y="46754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7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373236" y="46754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8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593169" y="46754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9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471825" y="4675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10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688572" y="4675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11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884326" y="4675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12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104372" y="4675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13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297987" y="4675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14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509541" y="4675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15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276342" y="467544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M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414542" y="590654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kDa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501104" y="14863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kern="0" dirty="0" smtClean="0">
                <a:solidFill>
                  <a:prstClr val="black"/>
                </a:solidFill>
              </a:rPr>
              <a:t>75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01104" y="174020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kern="0" dirty="0" smtClean="0">
                <a:solidFill>
                  <a:prstClr val="black"/>
                </a:solidFill>
              </a:rPr>
              <a:t>50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01104" y="199803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kern="0" dirty="0" smtClean="0">
                <a:solidFill>
                  <a:prstClr val="black"/>
                </a:solidFill>
              </a:rPr>
              <a:t>37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891036" y="590654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</a:rPr>
              <a:t>kDa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977598" y="147280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kern="0" dirty="0" smtClean="0">
                <a:solidFill>
                  <a:prstClr val="black"/>
                </a:solidFill>
              </a:rPr>
              <a:t>75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977598" y="172664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kern="0" dirty="0" smtClean="0">
                <a:solidFill>
                  <a:prstClr val="black"/>
                </a:solidFill>
              </a:rPr>
              <a:t>50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977598" y="19844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kern="0" dirty="0" smtClean="0">
                <a:solidFill>
                  <a:prstClr val="black"/>
                </a:solidFill>
              </a:rPr>
              <a:t>37</a:t>
            </a:r>
            <a:endParaRPr kumimoji="0" lang="ja-JP" altLang="en-US" sz="10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</a:endParaRPr>
          </a:p>
        </p:txBody>
      </p:sp>
      <p:sp>
        <p:nvSpPr>
          <p:cNvPr id="29" name="テキスト ボックス 322"/>
          <p:cNvSpPr txBox="1">
            <a:spLocks noChangeArrowheads="1"/>
          </p:cNvSpPr>
          <p:nvPr/>
        </p:nvSpPr>
        <p:spPr bwMode="auto">
          <a:xfrm>
            <a:off x="42825" y="3022698"/>
            <a:ext cx="6815175" cy="17338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ts val="1600"/>
              </a:lnSpc>
            </a:pPr>
            <a:r>
              <a:rPr lang="en-US" altLang="ja-JP" sz="1100" b="1" dirty="0" smtClean="0">
                <a:latin typeface="Times New Roman" pitchFamily="18" charset="0"/>
                <a:cs typeface="Times New Roman" pitchFamily="18" charset="0"/>
              </a:rPr>
              <a:t>Fig. S1 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S-PAGE analysis of the expression of the wild-type </a:t>
            </a:r>
            <a:r>
              <a:rPr lang="en-US" altLang="ja-JP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yc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its mutants in </a:t>
            </a: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</a:p>
          <a:p>
            <a:pPr>
              <a:lnSpc>
                <a:spcPts val="1600"/>
              </a:lnSpc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M, molecular mass markers</a:t>
            </a:r>
          </a:p>
          <a:p>
            <a:pPr>
              <a:lnSpc>
                <a:spcPts val="1600"/>
              </a:lnSpc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1, </a:t>
            </a: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aining </a:t>
            </a:r>
            <a:r>
              <a:rPr lang="en-US" altLang="ja-JP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YP-camAB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P450 expression vector)</a:t>
            </a:r>
          </a:p>
          <a:p>
            <a:pPr>
              <a:lnSpc>
                <a:spcPts val="1600"/>
              </a:lnSpc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2, </a:t>
            </a: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ng wild-type </a:t>
            </a:r>
            <a:r>
              <a:rPr lang="en-US" altLang="ja-JP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yc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>
              <a:lnSpc>
                <a:spcPts val="1600"/>
              </a:lnSpc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-15,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ng 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 </a:t>
            </a:r>
            <a:r>
              <a:rPr lang="en-US" altLang="ja-JP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yc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utant</a:t>
            </a:r>
          </a:p>
          <a:p>
            <a:pPr>
              <a:lnSpc>
                <a:spcPts val="1600"/>
              </a:lnSpc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Lane 3, RM92; Lane 4, R111Q; Lane 5, S155F; Lane 6, V358L; Lane 7, R111Q/S155F; Lane 8, R111Q/V358L;     </a:t>
            </a:r>
          </a:p>
          <a:p>
            <a:pPr>
              <a:lnSpc>
                <a:spcPts val="1600"/>
              </a:lnSpc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ane 9, S155F/V358L; Lane 10, RM96; Lane 11, W44R; Lane 12, RM98; Lane 13, V135G; Lane 14, E355K;  </a:t>
            </a:r>
          </a:p>
          <a:p>
            <a:pPr>
              <a:lnSpc>
                <a:spcPts val="1600"/>
              </a:lnSpc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ane 15, V135G/E355K)</a:t>
            </a:r>
          </a:p>
        </p:txBody>
      </p:sp>
    </p:spTree>
    <p:extLst>
      <p:ext uri="{BB962C8B-B14F-4D97-AF65-F5344CB8AC3E}">
        <p14:creationId xmlns:p14="http://schemas.microsoft.com/office/powerpoint/2010/main" val="40366584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1AD1E559-9154-4E91-8377-396471C2661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97238" y="1175723"/>
          <a:ext cx="3063241" cy="16882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DB96AD98-9078-4872-9E46-B14221DBFE8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546529" y="1198230"/>
          <a:ext cx="3047702" cy="19475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397238" y="920032"/>
            <a:ext cx="295274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8" dirty="0">
                <a:solidFill>
                  <a:prstClr val="black"/>
                </a:solidFill>
              </a:rPr>
              <a:t>a)</a:t>
            </a:r>
            <a:endParaRPr lang="ja-JP" altLang="en-US" sz="1108" dirty="0">
              <a:solidFill>
                <a:prstClr val="black"/>
              </a:solidFill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46529" y="920031"/>
            <a:ext cx="30328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8" dirty="0">
                <a:solidFill>
                  <a:prstClr val="black"/>
                </a:solidFill>
              </a:rPr>
              <a:t>b)</a:t>
            </a:r>
            <a:endParaRPr lang="ja-JP" altLang="en-US" sz="1108" dirty="0">
              <a:solidFill>
                <a:prstClr val="black"/>
              </a:solidFill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835874" y="2694018"/>
            <a:ext cx="402674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23" dirty="0">
                <a:solidFill>
                  <a:prstClr val="black"/>
                </a:solidFill>
              </a:rPr>
              <a:t>days</a:t>
            </a:r>
            <a:endParaRPr lang="ja-JP" altLang="en-US" sz="923" dirty="0">
              <a:solidFill>
                <a:prstClr val="black"/>
              </a:solidFill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4965935" y="2694018"/>
            <a:ext cx="402674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23" dirty="0">
                <a:solidFill>
                  <a:prstClr val="black"/>
                </a:solidFill>
              </a:rPr>
              <a:t>days</a:t>
            </a:r>
            <a:endParaRPr lang="ja-JP" altLang="en-US" sz="923" dirty="0">
              <a:solidFill>
                <a:prstClr val="black"/>
              </a:solidFill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103985" y="1659826"/>
            <a:ext cx="500458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23" dirty="0">
                <a:solidFill>
                  <a:prstClr val="black"/>
                </a:solidFill>
                <a:latin typeface="Symbol" panose="05050102010706020507" pitchFamily="18" charset="2"/>
              </a:rPr>
              <a:t>m</a:t>
            </a:r>
            <a:r>
              <a:rPr lang="en-US" altLang="ja-JP" sz="923" dirty="0">
                <a:solidFill>
                  <a:prstClr val="black"/>
                </a:solidFill>
              </a:rPr>
              <a:t>g/mL</a:t>
            </a:r>
            <a:endParaRPr lang="ja-JP" altLang="en-US" sz="923" dirty="0">
              <a:solidFill>
                <a:prstClr val="black"/>
              </a:solidFill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 rot="16200000">
            <a:off x="3253276" y="1659826"/>
            <a:ext cx="500458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23" dirty="0">
                <a:solidFill>
                  <a:prstClr val="black"/>
                </a:solidFill>
                <a:latin typeface="Symbol" panose="05050102010706020507" pitchFamily="18" charset="2"/>
              </a:rPr>
              <a:t>m</a:t>
            </a:r>
            <a:r>
              <a:rPr lang="en-US" altLang="ja-JP" sz="923" dirty="0">
                <a:solidFill>
                  <a:prstClr val="black"/>
                </a:solidFill>
              </a:rPr>
              <a:t>g/mL</a:t>
            </a:r>
            <a:endParaRPr lang="ja-JP" altLang="en-US" sz="923" dirty="0">
              <a:solidFill>
                <a:prstClr val="black"/>
              </a:solidFill>
            </a:endParaRPr>
          </a:p>
        </p:txBody>
      </p:sp>
      <p:sp>
        <p:nvSpPr>
          <p:cNvPr id="14" name="テキスト ボックス 322"/>
          <p:cNvSpPr txBox="1">
            <a:spLocks noChangeArrowheads="1"/>
          </p:cNvSpPr>
          <p:nvPr/>
        </p:nvSpPr>
        <p:spPr bwMode="auto">
          <a:xfrm>
            <a:off x="44624" y="3275856"/>
            <a:ext cx="6768752" cy="707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ts val="1600"/>
              </a:lnSpc>
            </a:pP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ja-JP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course of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inamicins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duction 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A11725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and TPMA0075 (b).</a:t>
            </a:r>
            <a:endParaRPr lang="ja-JP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600"/>
              </a:lnSpc>
            </a:pP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duction of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inamicins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determined based on the peak area from HPLC, as described in Materials and Methods section.</a:t>
            </a:r>
            <a:endParaRPr lang="ja-JP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4358731"/>
      </p:ext>
    </p:extLst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0</TotalTime>
  <Words>1333</Words>
  <Application>Microsoft Office PowerPoint</Application>
  <PresentationFormat>画面に合わせる (4:3)</PresentationFormat>
  <Paragraphs>628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8</vt:i4>
      </vt:variant>
    </vt:vector>
  </HeadingPairs>
  <TitlesOfParts>
    <vt:vector size="18" baseType="lpstr">
      <vt:lpstr>ＭＳ Ｐゴシック</vt:lpstr>
      <vt:lpstr>ＭＳ 明朝</vt:lpstr>
      <vt:lpstr>Arial</vt:lpstr>
      <vt:lpstr>Calibri</vt:lpstr>
      <vt:lpstr>Calibri Light</vt:lpstr>
      <vt:lpstr>Century</vt:lpstr>
      <vt:lpstr>Symbol</vt:lpstr>
      <vt:lpstr>Times New Roman</vt:lpstr>
      <vt:lpstr>標準デザイン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icrobiology</dc:creator>
  <cp:lastModifiedBy>飯坂 洋平</cp:lastModifiedBy>
  <cp:revision>182</cp:revision>
  <cp:lastPrinted>2021-05-13T05:47:19Z</cp:lastPrinted>
  <dcterms:created xsi:type="dcterms:W3CDTF">2012-07-07T10:53:18Z</dcterms:created>
  <dcterms:modified xsi:type="dcterms:W3CDTF">2021-09-24T01:14:16Z</dcterms:modified>
</cp:coreProperties>
</file>